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41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72009" y="-8281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6</a:t>
            </a:r>
            <a:endParaRPr lang="en-GB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9070036"/>
              </p:ext>
            </p:extLst>
          </p:nvPr>
        </p:nvGraphicFramePr>
        <p:xfrm>
          <a:off x="116632" y="222630"/>
          <a:ext cx="6624739" cy="8191460"/>
        </p:xfrm>
        <a:graphic>
          <a:graphicData uri="http://schemas.openxmlformats.org/drawingml/2006/table">
            <a:tbl>
              <a:tblPr/>
              <a:tblGrid>
                <a:gridCol w="785832"/>
                <a:gridCol w="886343"/>
                <a:gridCol w="785832"/>
                <a:gridCol w="822382"/>
                <a:gridCol w="785832"/>
                <a:gridCol w="886343"/>
                <a:gridCol w="785832"/>
                <a:gridCol w="886343"/>
              </a:tblGrid>
              <a:tr h="142539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B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rcoidosis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neumonia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ung Cancer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Symbo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Q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L2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FA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PST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2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K3R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ANE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RVI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ARCD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MR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MP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7orf5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OCS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DC14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LR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CHDC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CNJ15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LF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L17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5161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PCAT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IN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TN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466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ZDHHC19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4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PR8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AM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Y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2G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4379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IAA102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14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MD1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CSTD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CW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M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PGEF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A1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E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AS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XNL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090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BC1D2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ACAM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IM5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CTP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44119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BBR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ZU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16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QC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GLN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ACH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FX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3565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LF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DD45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10013468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TGA2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FAP3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UN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234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Y6E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179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KBP9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14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IPK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K5RAP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F20L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SP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5084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28464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40217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DD45G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J4309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PR17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16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RMD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AP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EC5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SBPL1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MPK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5orf2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PB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MT5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QP1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C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A5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BTD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XCL1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IAA0319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PR17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DORA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TPRIPL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IN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P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H2D3C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J3009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AMC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BP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K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TN2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PS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GIC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D1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F1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K3C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MEM45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AMF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44031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PDL3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UX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LP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X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BE2C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EM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DN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515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DUFAF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GALT1C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3GAL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2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ML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PBP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NRF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TSK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5orf29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PI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PP1R3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B1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SC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X58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PPE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5152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RP1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S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52699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MEM176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RP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PT1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614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GFC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DAC7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00C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GMS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P9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S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LRA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MP2K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V2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4orf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SF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31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OCD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PN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SB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RCO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1LC3B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231.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MK1D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DC109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40079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FXL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CAM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SAP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783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H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IF1A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O4C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F20L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R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199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P27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NJL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NASE1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4615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12A6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R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15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KM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J4295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RL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30A1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MX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DC147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NX2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38912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DI4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25A4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5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P2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P1A3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MPT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4835" marR="4835" marT="48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C649270</a:t>
                      </a:r>
                    </a:p>
                  </a:txBody>
                  <a:tcPr marL="4835" marR="4835" marT="483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627470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23</Words>
  <Application>Microsoft Office PowerPoint</Application>
  <PresentationFormat>On-screen Show (4:3)</PresentationFormat>
  <Paragraphs>4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7</cp:revision>
  <dcterms:created xsi:type="dcterms:W3CDTF">2013-03-09T22:22:05Z</dcterms:created>
  <dcterms:modified xsi:type="dcterms:W3CDTF">2013-03-09T22:30:12Z</dcterms:modified>
</cp:coreProperties>
</file>